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2" r:id="rId1"/>
  </p:sldMasterIdLst>
  <p:sldIdLst>
    <p:sldId id="263" r:id="rId2"/>
  </p:sldIdLst>
  <p:sldSz cx="6858000" cy="9906000" type="A4"/>
  <p:notesSz cx="7102475" cy="102330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5F89BED-2864-DFB1-7710-0FB905664D35}" name="David Church" initials="DC" userId="3292adfe893c5359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avid Church" initials="DC" lastIdx="39" clrIdx="0"/>
  <p:cmAuthor id="2" name="SEMPLE Robert" initials="SR" lastIdx="18" clrIdx="1">
    <p:extLst>
      <p:ext uri="{19B8F6BF-5375-455C-9EA6-DF929625EA0E}">
        <p15:presenceInfo xmlns:p15="http://schemas.microsoft.com/office/powerpoint/2012/main" userId="S::rsemple@ed.ac.uk::ac6b1c7c-787e-4006-a612-03eef1dbef4c" providerId="AD"/>
      </p:ext>
    </p:extLst>
  </p:cmAuthor>
  <p:cmAuthor id="3" name="BARKER, Peter (CAMBRIDGE UNIVERSITY HOSPITALS NHS FOUNDATION TRUST)" initials="BP(UHNFT" lastIdx="3" clrIdx="2">
    <p:extLst>
      <p:ext uri="{19B8F6BF-5375-455C-9EA6-DF929625EA0E}">
        <p15:presenceInfo xmlns:p15="http://schemas.microsoft.com/office/powerpoint/2012/main" userId="BARKER, Peter (CAMBRIDGE UNIVERSITY HOSPITALS NHS FOUNDATION TRUST)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524" autoAdjust="0"/>
    <p:restoredTop sz="93265" autoAdjust="0"/>
  </p:normalViewPr>
  <p:slideViewPr>
    <p:cSldViewPr snapToGrid="0">
      <p:cViewPr varScale="1">
        <p:scale>
          <a:sx n="72" d="100"/>
          <a:sy n="72" d="100"/>
        </p:scale>
        <p:origin x="3684" y="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A06DA-A441-428C-ACEA-122A4BEA7978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5ED22-6C0A-422D-9DD6-EBDDEEB1A1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1204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A06DA-A441-428C-ACEA-122A4BEA7978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5ED22-6C0A-422D-9DD6-EBDDEEB1A1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87539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A06DA-A441-428C-ACEA-122A4BEA7978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5ED22-6C0A-422D-9DD6-EBDDEEB1A1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1990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A06DA-A441-428C-ACEA-122A4BEA7978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5ED22-6C0A-422D-9DD6-EBDDEEB1A1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417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A06DA-A441-428C-ACEA-122A4BEA7978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5ED22-6C0A-422D-9DD6-EBDDEEB1A1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61758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A06DA-A441-428C-ACEA-122A4BEA7978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5ED22-6C0A-422D-9DD6-EBDDEEB1A1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89466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A06DA-A441-428C-ACEA-122A4BEA7978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5ED22-6C0A-422D-9DD6-EBDDEEB1A1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0797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A06DA-A441-428C-ACEA-122A4BEA7978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5ED22-6C0A-422D-9DD6-EBDDEEB1A1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2252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A06DA-A441-428C-ACEA-122A4BEA7978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5ED22-6C0A-422D-9DD6-EBDDEEB1A1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7937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A06DA-A441-428C-ACEA-122A4BEA7978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5ED22-6C0A-422D-9DD6-EBDDEEB1A1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8016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A06DA-A441-428C-ACEA-122A4BEA7978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5ED22-6C0A-422D-9DD6-EBDDEEB1A1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7211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A06DA-A441-428C-ACEA-122A4BEA7978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05ED22-6C0A-422D-9DD6-EBDDEEB1A1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7002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5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FC54CA15-6488-4387-937C-AF982972AC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99" y="4998993"/>
            <a:ext cx="3371452" cy="1964074"/>
          </a:xfrm>
          <a:prstGeom prst="rect">
            <a:avLst/>
          </a:prstGeom>
        </p:spPr>
      </p:pic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D3C9EF1D-5AED-4EEC-82B5-246EBCD745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417199"/>
              </p:ext>
            </p:extLst>
          </p:nvPr>
        </p:nvGraphicFramePr>
        <p:xfrm>
          <a:off x="3375343" y="4983168"/>
          <a:ext cx="3571405" cy="20029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5310201" imgH="2977754" progId="Prism9.Document">
                  <p:embed/>
                </p:oleObj>
              </mc:Choice>
              <mc:Fallback>
                <p:oleObj name="Prism 9" r:id="rId3" imgW="5310201" imgH="297775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75343" y="4983168"/>
                        <a:ext cx="3571405" cy="20029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7" name="Picture 26">
            <a:extLst>
              <a:ext uri="{FF2B5EF4-FFF2-40B4-BE49-F238E27FC236}">
                <a16:creationId xmlns:a16="http://schemas.microsoft.com/office/drawing/2014/main" id="{4264945C-A44B-4449-A2C0-3D9414AC9A4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95451" y="2284422"/>
            <a:ext cx="3571405" cy="1999729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A9E8BA08-7191-425A-815D-F89190A1681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378" y="2306011"/>
            <a:ext cx="3382406" cy="193809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62E0ECB-5440-4B72-B080-DFEE908C39E2}"/>
              </a:ext>
            </a:extLst>
          </p:cNvPr>
          <p:cNvSpPr txBox="1"/>
          <p:nvPr/>
        </p:nvSpPr>
        <p:spPr>
          <a:xfrm>
            <a:off x="-32206" y="1902951"/>
            <a:ext cx="535493" cy="349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BFA0419-B9E8-4984-A16D-5DC39D71B911}"/>
              </a:ext>
            </a:extLst>
          </p:cNvPr>
          <p:cNvSpPr txBox="1"/>
          <p:nvPr/>
        </p:nvSpPr>
        <p:spPr>
          <a:xfrm>
            <a:off x="3348352" y="1901457"/>
            <a:ext cx="550009" cy="349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11E9AFB-B77E-4848-9F57-3DE58FD64E4C}"/>
              </a:ext>
            </a:extLst>
          </p:cNvPr>
          <p:cNvSpPr txBox="1"/>
          <p:nvPr/>
        </p:nvSpPr>
        <p:spPr>
          <a:xfrm>
            <a:off x="-38760" y="4631466"/>
            <a:ext cx="535493" cy="349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C436645-CD64-422E-9ECA-0927F76B154B}"/>
              </a:ext>
            </a:extLst>
          </p:cNvPr>
          <p:cNvSpPr txBox="1"/>
          <p:nvPr/>
        </p:nvSpPr>
        <p:spPr>
          <a:xfrm>
            <a:off x="3348351" y="4626918"/>
            <a:ext cx="550009" cy="349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2A52FBD-03AE-416A-B411-4460D88372F1}"/>
              </a:ext>
            </a:extLst>
          </p:cNvPr>
          <p:cNvSpPr txBox="1"/>
          <p:nvPr/>
        </p:nvSpPr>
        <p:spPr>
          <a:xfrm>
            <a:off x="878083" y="1948195"/>
            <a:ext cx="1517156" cy="349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nt 1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588FBB6-2B2A-48ED-9E8F-D8F536384114}"/>
              </a:ext>
            </a:extLst>
          </p:cNvPr>
          <p:cNvSpPr txBox="1"/>
          <p:nvPr/>
        </p:nvSpPr>
        <p:spPr>
          <a:xfrm>
            <a:off x="4524281" y="1948195"/>
            <a:ext cx="1517156" cy="349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nt 1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48BC281-BAA8-4D62-9789-DFE6FB6BFFAB}"/>
              </a:ext>
            </a:extLst>
          </p:cNvPr>
          <p:cNvSpPr txBox="1"/>
          <p:nvPr/>
        </p:nvSpPr>
        <p:spPr>
          <a:xfrm>
            <a:off x="878083" y="4682717"/>
            <a:ext cx="1517156" cy="349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nt 1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A17D373-12EB-4384-9265-9DC013ACB5D8}"/>
              </a:ext>
            </a:extLst>
          </p:cNvPr>
          <p:cNvSpPr txBox="1"/>
          <p:nvPr/>
        </p:nvSpPr>
        <p:spPr>
          <a:xfrm>
            <a:off x="4524281" y="4682717"/>
            <a:ext cx="1517156" cy="349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nt 13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B672B09B-DB38-42E3-A36B-03DE942CABB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80534" b="17347"/>
          <a:stretch/>
        </p:blipFill>
        <p:spPr>
          <a:xfrm>
            <a:off x="2732655" y="7213731"/>
            <a:ext cx="473397" cy="358378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3C249A4C-F9D5-4878-913C-3D513915ECA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r="81764" b="7660"/>
          <a:stretch/>
        </p:blipFill>
        <p:spPr>
          <a:xfrm>
            <a:off x="-1" y="7029150"/>
            <a:ext cx="473397" cy="433596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8D0AB833-CCB2-49E1-B494-90B9A6856C6A}"/>
              </a:ext>
            </a:extLst>
          </p:cNvPr>
          <p:cNvSpPr txBox="1"/>
          <p:nvPr/>
        </p:nvSpPr>
        <p:spPr>
          <a:xfrm>
            <a:off x="351377" y="7162017"/>
            <a:ext cx="2360284" cy="349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fasting plasm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47B559A-4C89-453A-80C7-D4E408AAF703}"/>
              </a:ext>
            </a:extLst>
          </p:cNvPr>
          <p:cNvSpPr txBox="1"/>
          <p:nvPr/>
        </p:nvSpPr>
        <p:spPr>
          <a:xfrm>
            <a:off x="3051636" y="7158864"/>
            <a:ext cx="3981107" cy="349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sma following addition of human insulin</a:t>
            </a:r>
          </a:p>
        </p:txBody>
      </p:sp>
    </p:spTree>
    <p:extLst>
      <p:ext uri="{BB962C8B-B14F-4D97-AF65-F5344CB8AC3E}">
        <p14:creationId xmlns:p14="http://schemas.microsoft.com/office/powerpoint/2010/main" val="3021262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09</TotalTime>
  <Words>28</Words>
  <Application>Microsoft Office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Church</dc:creator>
  <cp:lastModifiedBy>David Church</cp:lastModifiedBy>
  <cp:revision>160</cp:revision>
  <cp:lastPrinted>2021-04-22T10:20:52Z</cp:lastPrinted>
  <dcterms:created xsi:type="dcterms:W3CDTF">2018-10-24T23:58:48Z</dcterms:created>
  <dcterms:modified xsi:type="dcterms:W3CDTF">2023-08-16T18:46:46Z</dcterms:modified>
</cp:coreProperties>
</file>